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423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Estilo oscuro 2 - Énfasis 5/Énfasis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Estilo oscuro 2 - Énfasis 3/Énfasis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Estilo oscuro 2 - Énfasis 1/Énfasis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5202B0CA-FC54-4496-8BCA-5EF66A818D29}" styleName="Estilo oscuro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AF606853-7671-496A-8E4F-DF71F8EC918B}" styleName="Estilo oscuro 1 - Énfasis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25E5076-3810-47DD-B79F-674D7AD40C01}" styleName="Estilo oscuro 1 - Énfasis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8034E78-7F5D-4C2E-B375-FC64B27BC917}" styleName="Estilo oscuro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566"/>
    <p:restoredTop sz="93575"/>
  </p:normalViewPr>
  <p:slideViewPr>
    <p:cSldViewPr snapToGrid="0">
      <p:cViewPr varScale="1">
        <p:scale>
          <a:sx n="66" d="100"/>
          <a:sy n="66" d="100"/>
        </p:scale>
        <p:origin x="960" y="192"/>
      </p:cViewPr>
      <p:guideLst>
        <p:guide orient="horz" pos="2160"/>
        <p:guide pos="2880"/>
        <p:guide orient="horz" pos="42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D1526C-9095-C846-A70B-0FB3CA36D0E9}" type="datetimeFigureOut">
              <a:rPr lang="es-ES" smtClean="0"/>
              <a:t>3/6/19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C46150-FE0A-644F-9B06-944E72A71C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141314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108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22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970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3103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820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554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33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2787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682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624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799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063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a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6929721"/>
              </p:ext>
            </p:extLst>
          </p:nvPr>
        </p:nvGraphicFramePr>
        <p:xfrm>
          <a:off x="1216325" y="1084951"/>
          <a:ext cx="5563558" cy="382333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7715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98640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Primer nam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sequence 5'-&gt;3' 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</a:rPr>
                        <a:t>VP8_P4_FW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PT" sz="1200" u="none" strike="noStrike">
                          <a:effectLst/>
                        </a:rPr>
                        <a:t>TACAGT</a:t>
                      </a:r>
                      <a:r>
                        <a:rPr lang="pt-PT" sz="1200" u="sng" strike="noStrike">
                          <a:effectLst/>
                        </a:rPr>
                        <a:t>GGATCC</a:t>
                      </a:r>
                      <a:r>
                        <a:rPr lang="pt-PT" sz="1200" u="none" strike="noStrike">
                          <a:effectLst/>
                        </a:rPr>
                        <a:t>GTTTTAGATGGTCCTTATCAA</a:t>
                      </a:r>
                      <a:endParaRPr lang="pt-PT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VP8_P4_RE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_tradnl" sz="1200" u="none" strike="noStrike">
                          <a:effectLst/>
                        </a:rPr>
                        <a:t>ATCTATTATAAACCATTATTGATATATTCA</a:t>
                      </a:r>
                      <a:endParaRPr lang="es-ES_tradnl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VP8_P6_FW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_tradnl" sz="1200" u="none" strike="noStrike">
                          <a:effectLst/>
                        </a:rPr>
                        <a:t>ACAATA</a:t>
                      </a:r>
                      <a:r>
                        <a:rPr lang="es-ES_tradnl" sz="1200" u="sng" strike="noStrike">
                          <a:effectLst/>
                        </a:rPr>
                        <a:t>GGATCC</a:t>
                      </a:r>
                      <a:r>
                        <a:rPr lang="es-ES_tradnl" sz="1200" u="none" strike="noStrike">
                          <a:effectLst/>
                        </a:rPr>
                        <a:t>GTACTCGATGGTCCTTATCAA</a:t>
                      </a:r>
                      <a:endParaRPr lang="es-ES_tradnl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VP8_P6_RE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_tradnl" sz="1200" u="none" strike="noStrike">
                          <a:effectLst/>
                        </a:rPr>
                        <a:t>CTATTACAATCCAGTATTTATATATT</a:t>
                      </a:r>
                      <a:endParaRPr lang="es-ES_tradnl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VP8_P8_FW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_tradnl" sz="1200" u="none" strike="noStrike">
                          <a:effectLst/>
                        </a:rPr>
                        <a:t>ACAGTA</a:t>
                      </a:r>
                      <a:r>
                        <a:rPr lang="es-ES_tradnl" sz="1200" u="sng" strike="noStrike">
                          <a:effectLst/>
                        </a:rPr>
                        <a:t>GGATCC</a:t>
                      </a:r>
                      <a:r>
                        <a:rPr lang="es-ES_tradnl" sz="1200" u="none" strike="noStrike">
                          <a:effectLst/>
                        </a:rPr>
                        <a:t>ATGTTAGATGGTCCTTATCAG</a:t>
                      </a:r>
                      <a:endParaRPr lang="es-ES_tradnl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VP8_P8_RE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_tradnl" sz="1200" u="none" strike="noStrike">
                          <a:effectLst/>
                        </a:rPr>
                        <a:t>CTATTACAGACCATTATTAATATATTCA</a:t>
                      </a:r>
                      <a:endParaRPr lang="es-ES_tradnl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VP8_P9_FW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_tradnl" sz="1200" u="none" strike="noStrike">
                          <a:effectLst/>
                        </a:rPr>
                        <a:t>CTAGTG</a:t>
                      </a:r>
                      <a:r>
                        <a:rPr lang="es-ES_tradnl" sz="1200" u="sng" strike="noStrike">
                          <a:effectLst/>
                        </a:rPr>
                        <a:t>GGATCC</a:t>
                      </a:r>
                      <a:r>
                        <a:rPr lang="es-ES_tradnl" sz="1200" u="none" strike="noStrike">
                          <a:effectLst/>
                        </a:rPr>
                        <a:t>ACTCTTGATGGTCCATATCAA</a:t>
                      </a:r>
                      <a:endParaRPr lang="es-ES_tradnl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VP8_P9_RE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_tradnl" sz="1200" u="none" strike="noStrike">
                          <a:effectLst/>
                        </a:rPr>
                        <a:t>TTCTGAATCTATTATAAACCATTATTTATATATT</a:t>
                      </a:r>
                      <a:endParaRPr lang="es-ES_tradnl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VP8_P14_FW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_tradnl" sz="1200" u="none" strike="noStrike">
                          <a:effectLst/>
                        </a:rPr>
                        <a:t>TTAGTT</a:t>
                      </a:r>
                      <a:r>
                        <a:rPr lang="es-ES_tradnl" sz="1200" u="sng" strike="noStrike">
                          <a:effectLst/>
                        </a:rPr>
                        <a:t>GGATCC</a:t>
                      </a:r>
                      <a:r>
                        <a:rPr lang="es-ES_tradnl" sz="1200" u="none" strike="noStrike">
                          <a:effectLst/>
                        </a:rPr>
                        <a:t>ACATTAGATGGACCATATCAA</a:t>
                      </a:r>
                      <a:endParaRPr lang="es-ES_tradnl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VP8_P14_RE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_tradnl" sz="1200" u="none" strike="noStrike">
                          <a:effectLst/>
                        </a:rPr>
                        <a:t>CTATTAGAGCCCATTATTTATATACT</a:t>
                      </a:r>
                      <a:endParaRPr lang="es-ES_tradnl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VP8_P8_W113A_FW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_tradnl" sz="1200" u="none" strike="noStrike">
                          <a:effectLst/>
                        </a:rPr>
                        <a:t>TGGAAGAATAGCGACATTTCATGGT</a:t>
                      </a:r>
                      <a:endParaRPr lang="es-ES_tradnl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VP8_P8_W113A_RE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_tradnl" sz="1200" u="none" strike="noStrike">
                          <a:effectLst/>
                        </a:rPr>
                        <a:t>ACCATGAAATGTCGCTATTCTTCCA</a:t>
                      </a:r>
                      <a:endParaRPr lang="es-ES_tradnl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VP8_P8_R148A_FW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200" u="none" strike="noStrike">
                          <a:effectLst/>
                        </a:rPr>
                        <a:t>ATTATTCCAGCGTCTCAAGAGTCTAA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VP8_P8_R148A_RE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_tradnl" sz="1200" u="none" strike="noStrike">
                          <a:effectLst/>
                        </a:rPr>
                        <a:t>TTAGACTCTTGAGACGCTGGAATAAT</a:t>
                      </a:r>
                      <a:endParaRPr lang="es-ES_tradnl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VP8_P8_E151A_FW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_tradnl" sz="1200" u="none" strike="noStrike">
                          <a:effectLst/>
                        </a:rPr>
                        <a:t>AAGGTCTCAAGCGTCTAAGTGTAAT</a:t>
                      </a:r>
                      <a:endParaRPr lang="es-ES_tradnl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VP8_P8_E151A_RE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_tradnl" sz="1200" u="none" strike="noStrike">
                          <a:effectLst/>
                        </a:rPr>
                        <a:t>ATTACACTTAGACGCTTGAGACCTT</a:t>
                      </a:r>
                      <a:endParaRPr lang="es-ES_tradnl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VP8_P8_I112V_FW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_tradnl" sz="1200" u="none" strike="noStrike">
                          <a:effectLst/>
                        </a:rPr>
                        <a:t>ATATGGTGGAAGAGTATGGACATTTCAT</a:t>
                      </a:r>
                      <a:endParaRPr lang="es-ES_tradnl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VP8_P8_I112V_RE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</a:rPr>
                        <a:t>ATGAAATGTCCATACTCTTCCACCATA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6355010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14</TotalTime>
  <Words>131</Words>
  <Application>Microsoft Macintosh PowerPoint</Application>
  <PresentationFormat>Presentación en pantalla (4:3)</PresentationFormat>
  <Paragraphs>3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esús Rodríguez Díaz</dc:creator>
  <cp:lastModifiedBy>Microsoft Office User</cp:lastModifiedBy>
  <cp:revision>54</cp:revision>
  <dcterms:created xsi:type="dcterms:W3CDTF">2018-01-15T13:22:08Z</dcterms:created>
  <dcterms:modified xsi:type="dcterms:W3CDTF">2019-06-03T11:50:44Z</dcterms:modified>
</cp:coreProperties>
</file>